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7150100" cy="9450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38E06-BAEE-4A6D-896B-3B00BA3B6D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74023-9F0D-428E-8A2A-FE1011DE38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1D90A-5C51-4B6E-8147-B9BA8E14A1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2D0CA-2630-44BB-976A-AC9B06FF01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E0C12-DD55-4F10-9D75-2AE5A8A31B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1A321-B11C-4048-B6C0-45C136FE83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45C0A-3F10-47D3-8DF3-F7B09C3A6D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B4AD9-A251-4FB1-B3BE-EDFC3B8F66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CA0B3-8F42-4718-8FCC-5D1997A096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DA042-6458-4FF0-BD67-095F221DF5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8816D-A8DF-4AB4-AFFA-34E4DC3B76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5EB45-5C0B-4E2D-93E9-F1841C48EB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8FDD02-8C78-4239-996A-9772444CD1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68400" y="1033560"/>
            <a:ext cx="7765920" cy="5824440"/>
          </a:xfrm>
          <a:prstGeom prst="rect">
            <a:avLst/>
          </a:prstGeom>
          <a:ln w="0">
            <a:noFill/>
          </a:ln>
        </p:spPr>
      </p:pic>
      <p:grpSp>
        <p:nvGrpSpPr>
          <p:cNvPr id="42" name=""/>
          <p:cNvGrpSpPr/>
          <p:nvPr/>
        </p:nvGrpSpPr>
        <p:grpSpPr>
          <a:xfrm>
            <a:off x="1063800" y="703440"/>
            <a:ext cx="7029360" cy="279720"/>
            <a:chOff x="1063800" y="703440"/>
            <a:chExt cx="7029360" cy="279720"/>
          </a:xfrm>
        </p:grpSpPr>
        <p:sp>
          <p:nvSpPr>
            <p:cNvPr id="43" name=""/>
            <p:cNvSpPr/>
            <p:nvPr/>
          </p:nvSpPr>
          <p:spPr>
            <a:xfrm>
              <a:off x="2940120" y="70668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565800" y="70668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311560" y="70668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692360" y="70668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063800" y="70668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-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210200" y="70488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857840" y="70488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505480" y="704880"/>
              <a:ext cx="64800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2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153480" y="70488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801120" y="70344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445520" y="70344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9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54" name=""/>
          <p:cNvGraphicFramePr/>
          <p:nvPr/>
        </p:nvGraphicFramePr>
        <p:xfrm>
          <a:off x="250920" y="2627280"/>
          <a:ext cx="2301840" cy="150804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50920" y="2627280"/>
                    <a:ext cx="2301840" cy="1508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"/>
          <p:cNvSpPr/>
          <p:nvPr/>
        </p:nvSpPr>
        <p:spPr>
          <a:xfrm>
            <a:off x="2315520" y="50760"/>
            <a:ext cx="4871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olored PSCP  (To be extracted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7" name=""/>
          <p:cNvGraphicFramePr/>
          <p:nvPr/>
        </p:nvGraphicFramePr>
        <p:xfrm>
          <a:off x="2070000" y="1371600"/>
          <a:ext cx="6362640" cy="5438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70000" y="1371600"/>
                    <a:ext cx="6362640" cy="5438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9" name=""/>
          <p:cNvSpPr/>
          <p:nvPr/>
        </p:nvSpPr>
        <p:spPr>
          <a:xfrm>
            <a:off x="1607760" y="50760"/>
            <a:ext cx="62827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Pattern Extraction Window for Gene Lists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from Colored PSCP or WSCP Fil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-12960" y="3481560"/>
            <a:ext cx="1845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lor Templ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an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847880" y="3781440"/>
            <a:ext cx="428760" cy="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"/>
          <p:cNvGrpSpPr/>
          <p:nvPr/>
        </p:nvGrpSpPr>
        <p:grpSpPr>
          <a:xfrm>
            <a:off x="1676520" y="914400"/>
            <a:ext cx="7029360" cy="279720"/>
            <a:chOff x="1676520" y="914400"/>
            <a:chExt cx="7029360" cy="279720"/>
          </a:xfrm>
        </p:grpSpPr>
        <p:sp>
          <p:nvSpPr>
            <p:cNvPr id="63" name=""/>
            <p:cNvSpPr/>
            <p:nvPr/>
          </p:nvSpPr>
          <p:spPr>
            <a:xfrm>
              <a:off x="3552840" y="91764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178520" y="91764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924280" y="91764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305080" y="91764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676520" y="917640"/>
              <a:ext cx="62712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-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822920" y="91584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470560" y="91584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118200" y="915840"/>
              <a:ext cx="64800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2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6766200" y="91584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413840" y="91440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8058240" y="914400"/>
              <a:ext cx="647640" cy="2764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808080"/>
                  </a:solidFill>
                  <a:latin typeface="Arial"/>
                </a:rPr>
                <a:t>Day9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"/>
          <p:cNvSpPr/>
          <p:nvPr/>
        </p:nvSpPr>
        <p:spPr>
          <a:xfrm>
            <a:off x="27000" y="1600200"/>
            <a:ext cx="1959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ataset Load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equ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1143000" y="1219320"/>
            <a:ext cx="533520" cy="45720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066680" y="2209680"/>
            <a:ext cx="1371600" cy="91440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-57240" y="4319640"/>
            <a:ext cx="2088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eck the box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o ignore the CR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rom the colo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empl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1862280" y="4336560"/>
            <a:ext cx="482400" cy="28260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"/>
          <p:cNvGrpSpPr/>
          <p:nvPr/>
        </p:nvGrpSpPr>
        <p:grpSpPr>
          <a:xfrm>
            <a:off x="214200" y="4352400"/>
            <a:ext cx="6083280" cy="2271600"/>
            <a:chOff x="214200" y="4352400"/>
            <a:chExt cx="6083280" cy="2271600"/>
          </a:xfrm>
        </p:grpSpPr>
        <p:grpSp>
          <p:nvGrpSpPr>
            <p:cNvPr id="80" name=""/>
            <p:cNvGrpSpPr/>
            <p:nvPr/>
          </p:nvGrpSpPr>
          <p:grpSpPr>
            <a:xfrm>
              <a:off x="3016080" y="4352400"/>
              <a:ext cx="3281400" cy="335520"/>
              <a:chOff x="3016080" y="4352400"/>
              <a:chExt cx="3281400" cy="335520"/>
            </a:xfrm>
          </p:grpSpPr>
          <p:sp>
            <p:nvSpPr>
              <p:cNvPr id="81" name=""/>
              <p:cNvSpPr/>
              <p:nvPr/>
            </p:nvSpPr>
            <p:spPr>
              <a:xfrm flipV="1">
                <a:off x="3560760" y="4363560"/>
                <a:ext cx="0" cy="319320"/>
              </a:xfrm>
              <a:prstGeom prst="line">
                <a:avLst/>
              </a:prstGeom>
              <a:ln w="57240">
                <a:solidFill>
                  <a:srgbClr val="0000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V="1">
                <a:off x="3016080" y="4368960"/>
                <a:ext cx="0" cy="318960"/>
              </a:xfrm>
              <a:prstGeom prst="line">
                <a:avLst/>
              </a:prstGeom>
              <a:ln w="57240">
                <a:solidFill>
                  <a:srgbClr val="0000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V="1">
                <a:off x="6297480" y="4352400"/>
                <a:ext cx="0" cy="319320"/>
              </a:xfrm>
              <a:prstGeom prst="line">
                <a:avLst/>
              </a:prstGeom>
              <a:ln w="57240">
                <a:solidFill>
                  <a:srgbClr val="0000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5738760" y="4357800"/>
                <a:ext cx="0" cy="318960"/>
              </a:xfrm>
              <a:prstGeom prst="line">
                <a:avLst/>
              </a:prstGeom>
              <a:ln w="57240">
                <a:solidFill>
                  <a:srgbClr val="0000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5" name=""/>
            <p:cNvSpPr/>
            <p:nvPr/>
          </p:nvSpPr>
          <p:spPr>
            <a:xfrm flipV="1">
              <a:off x="214200" y="5800680"/>
              <a:ext cx="0" cy="318960"/>
            </a:xfrm>
            <a:prstGeom prst="line">
              <a:avLst/>
            </a:prstGeom>
            <a:ln w="57240">
              <a:solidFill>
                <a:srgbClr val="0000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25440" y="5707080"/>
              <a:ext cx="169236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RI files use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in the colo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templat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7" name=""/>
          <p:cNvGraphicFramePr/>
          <p:nvPr/>
        </p:nvGraphicFramePr>
        <p:xfrm>
          <a:off x="306360" y="1274760"/>
          <a:ext cx="8229600" cy="4011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6360" y="1274760"/>
                    <a:ext cx="8229600" cy="4011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9" name=""/>
          <p:cNvSpPr/>
          <p:nvPr/>
        </p:nvSpPr>
        <p:spPr>
          <a:xfrm>
            <a:off x="1469880" y="569880"/>
            <a:ext cx="619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Verification of Extracted Patterned Gen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18T03:50:59Z</dcterms:created>
  <dc:creator>Ming Yi</dc:creator>
  <dc:description/>
  <dc:language>en-US</dc:language>
  <cp:lastModifiedBy>Ming Yi</cp:lastModifiedBy>
  <dcterms:modified xsi:type="dcterms:W3CDTF">2005-04-18T21:34:05Z</dcterms:modified>
  <cp:revision>11</cp:revision>
  <dc:subject/>
  <dc:title>Slide 1</dc:title>
</cp:coreProperties>
</file>